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40" autoAdjust="0"/>
    <p:restoredTop sz="94660"/>
  </p:normalViewPr>
  <p:slideViewPr>
    <p:cSldViewPr snapToGrid="0">
      <p:cViewPr varScale="1">
        <p:scale>
          <a:sx n="67" d="100"/>
          <a:sy n="67" d="100"/>
        </p:scale>
        <p:origin x="84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2651-C93C-46C0-9340-453CF83F647A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35304-1179-4BDA-BCEE-E704490A0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4663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2651-C93C-46C0-9340-453CF83F647A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35304-1179-4BDA-BCEE-E704490A0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7990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2651-C93C-46C0-9340-453CF83F647A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35304-1179-4BDA-BCEE-E704490A0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879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2651-C93C-46C0-9340-453CF83F647A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35304-1179-4BDA-BCEE-E704490A0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72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2651-C93C-46C0-9340-453CF83F647A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35304-1179-4BDA-BCEE-E704490A0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624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2651-C93C-46C0-9340-453CF83F647A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35304-1179-4BDA-BCEE-E704490A0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02641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2651-C93C-46C0-9340-453CF83F647A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35304-1179-4BDA-BCEE-E704490A0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11090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2651-C93C-46C0-9340-453CF83F647A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35304-1179-4BDA-BCEE-E704490A0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6137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2651-C93C-46C0-9340-453CF83F647A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35304-1179-4BDA-BCEE-E704490A0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640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2651-C93C-46C0-9340-453CF83F647A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35304-1179-4BDA-BCEE-E704490A0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758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2651-C93C-46C0-9340-453CF83F647A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35304-1179-4BDA-BCEE-E704490A0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2712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2F2651-C93C-46C0-9340-453CF83F647A}" type="datetimeFigureOut">
              <a:rPr lang="en-US" smtClean="0"/>
              <a:t>12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935304-1179-4BDA-BCEE-E704490A0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51050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5221" y="474758"/>
            <a:ext cx="4764464" cy="521166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828800" y="1780610"/>
            <a:ext cx="50366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(a</a:t>
            </a:r>
            <a:r>
              <a:rPr lang="en-GB" dirty="0" smtClean="0"/>
              <a:t>)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28721" y="474757"/>
            <a:ext cx="5146601" cy="5211667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501444" y="1780609"/>
            <a:ext cx="5164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(b</a:t>
            </a:r>
            <a:r>
              <a:rPr lang="en-GB" dirty="0" smtClean="0"/>
              <a:t>)</a:t>
            </a:r>
            <a:endParaRPr lang="en-US" dirty="0"/>
          </a:p>
        </p:txBody>
      </p:sp>
      <p:sp>
        <p:nvSpPr>
          <p:cNvPr id="2" name="Rectangle 1"/>
          <p:cNvSpPr/>
          <p:nvPr/>
        </p:nvSpPr>
        <p:spPr>
          <a:xfrm>
            <a:off x="405443" y="5829671"/>
            <a:ext cx="7981319" cy="3886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57200" indent="457200">
              <a:lnSpc>
                <a:spcPct val="107000"/>
              </a:lnSpc>
              <a:spcAft>
                <a:spcPts val="800"/>
              </a:spcAft>
            </a:pPr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1a&amp;b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alibration curves of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-BHC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(b)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β- BHC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519561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9924" y="596349"/>
            <a:ext cx="5596977" cy="506150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82436" y="596348"/>
            <a:ext cx="5158853" cy="506150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487606" y="1692322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(s)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7031387" y="1692322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(t)</a:t>
            </a:r>
            <a:endParaRPr lang="en-US" b="1" dirty="0"/>
          </a:p>
        </p:txBody>
      </p:sp>
      <p:sp>
        <p:nvSpPr>
          <p:cNvPr id="2" name="Rectangle 1"/>
          <p:cNvSpPr/>
          <p:nvPr/>
        </p:nvSpPr>
        <p:spPr>
          <a:xfrm>
            <a:off x="1145540" y="5801096"/>
            <a:ext cx="7698423" cy="3886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57200" indent="457200">
              <a:lnSpc>
                <a:spcPct val="107000"/>
              </a:lnSpc>
              <a:spcAft>
                <a:spcPts val="800"/>
              </a:spcAft>
            </a:pPr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 1s&amp;t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alibration curves of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)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drin Ketone,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)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thoxychlor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873451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3507" y="453774"/>
            <a:ext cx="7698732" cy="508721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756848" y="1692323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(u</a:t>
            </a:r>
            <a:r>
              <a:rPr lang="en-GB" dirty="0" smtClean="0"/>
              <a:t>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390146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/>
          <a:stretch>
            <a:fillRect/>
          </a:stretch>
        </p:blipFill>
        <p:spPr>
          <a:xfrm>
            <a:off x="473335" y="427778"/>
            <a:ext cx="5392004" cy="523622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006221" y="1828800"/>
            <a:ext cx="50526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(c)</a:t>
            </a:r>
            <a:endParaRPr lang="en-US" sz="2400" b="1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12675" y="427777"/>
            <a:ext cx="5352711" cy="5236225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7132932" y="1828800"/>
            <a:ext cx="5164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(d</a:t>
            </a:r>
            <a:r>
              <a:rPr lang="en-GB" dirty="0" smtClean="0"/>
              <a:t>)</a:t>
            </a:r>
            <a:endParaRPr lang="en-US" dirty="0"/>
          </a:p>
        </p:txBody>
      </p:sp>
      <p:sp>
        <p:nvSpPr>
          <p:cNvPr id="2" name="Rectangle 1"/>
          <p:cNvSpPr/>
          <p:nvPr/>
        </p:nvSpPr>
        <p:spPr>
          <a:xfrm>
            <a:off x="2006221" y="5787509"/>
            <a:ext cx="670915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I1c&amp;d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Calibration curves of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 (c)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δ –BHC,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 (d)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Lindane 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63160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5077" y="757073"/>
            <a:ext cx="4967047" cy="520035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82568" y="791643"/>
            <a:ext cx="5304520" cy="516578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596789" y="1678674"/>
            <a:ext cx="4748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/>
              <a:t>(e)</a:t>
            </a:r>
            <a:endParaRPr lang="en-US" sz="20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6748890" y="1678674"/>
            <a:ext cx="4305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/>
              <a:t>(f)</a:t>
            </a:r>
            <a:endParaRPr lang="en-US" sz="2000" b="1" dirty="0"/>
          </a:p>
        </p:txBody>
      </p:sp>
      <p:sp>
        <p:nvSpPr>
          <p:cNvPr id="2" name="Rectangle 1"/>
          <p:cNvSpPr/>
          <p:nvPr/>
        </p:nvSpPr>
        <p:spPr>
          <a:xfrm>
            <a:off x="605076" y="5957427"/>
            <a:ext cx="8710373" cy="3886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57200" indent="457200">
              <a:lnSpc>
                <a:spcPct val="107000"/>
              </a:lnSpc>
              <a:spcAft>
                <a:spcPts val="800"/>
              </a:spcAft>
            </a:pPr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 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e&amp;f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libration curves of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e)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eptachlor (HC),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)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ldrin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01091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749489" y="639685"/>
            <a:ext cx="10810165" cy="5218189"/>
            <a:chOff x="749489" y="639686"/>
            <a:chExt cx="10810165" cy="4423634"/>
          </a:xfrm>
        </p:grpSpPr>
        <p:pic>
          <p:nvPicPr>
            <p:cNvPr id="4" name="Picture 3"/>
            <p:cNvPicPr/>
            <p:nvPr/>
          </p:nvPicPr>
          <p:blipFill>
            <a:blip r:embed="rId2"/>
            <a:stretch>
              <a:fillRect/>
            </a:stretch>
          </p:blipFill>
          <p:spPr>
            <a:xfrm>
              <a:off x="749489" y="639686"/>
              <a:ext cx="5664959" cy="442363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550925" y="639686"/>
              <a:ext cx="5008729" cy="442363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6" name="TextBox 5"/>
          <p:cNvSpPr txBox="1"/>
          <p:nvPr/>
        </p:nvSpPr>
        <p:spPr>
          <a:xfrm>
            <a:off x="1746913" y="1828800"/>
            <a:ext cx="4987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(g</a:t>
            </a:r>
            <a:r>
              <a:rPr lang="en-GB" dirty="0" smtClean="0"/>
              <a:t>)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7411872" y="1921133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(h)</a:t>
            </a:r>
            <a:endParaRPr lang="en-US" b="1" dirty="0"/>
          </a:p>
        </p:txBody>
      </p:sp>
      <p:sp>
        <p:nvSpPr>
          <p:cNvPr id="2" name="Rectangle 1"/>
          <p:cNvSpPr/>
          <p:nvPr/>
        </p:nvSpPr>
        <p:spPr>
          <a:xfrm>
            <a:off x="454924" y="5977622"/>
            <a:ext cx="864621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I 1g&amp;h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calibration curves of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 (g)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Heptachlor epoxide (HCE)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h)</a:t>
            </a:r>
            <a:r>
              <a:rPr lang="en-US" dirty="0">
                <a:latin typeface="Times New Roman" panose="02020603050405020304" pitchFamily="18" charset="0"/>
                <a:ea typeface="TimesNewRomanPSMT"/>
              </a:rPr>
              <a:t> α –Chlordan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051243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0993" y="537254"/>
            <a:ext cx="5351317" cy="523489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55140" y="537254"/>
            <a:ext cx="5595582" cy="523489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129051" y="1746913"/>
            <a:ext cx="4523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(i)</a:t>
            </a:r>
            <a:endParaRPr lang="en-US" sz="2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6400800" y="1746912"/>
            <a:ext cx="46307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(j)</a:t>
            </a:r>
            <a:endParaRPr lang="en-US" sz="2400" b="1" dirty="0"/>
          </a:p>
        </p:txBody>
      </p:sp>
      <p:sp>
        <p:nvSpPr>
          <p:cNvPr id="2" name="Rectangle 1"/>
          <p:cNvSpPr/>
          <p:nvPr/>
        </p:nvSpPr>
        <p:spPr>
          <a:xfrm>
            <a:off x="976311" y="5934760"/>
            <a:ext cx="802481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I 1 i&amp;j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Calibration curves of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i)</a:t>
            </a:r>
            <a:r>
              <a:rPr lang="en-US" dirty="0">
                <a:latin typeface="Times New Roman" panose="02020603050405020304" pitchFamily="18" charset="0"/>
                <a:ea typeface="TimesNewRomanPSMT"/>
              </a:rPr>
              <a:t> γ-Chlordane,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j)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TimesNewRomanPSMT"/>
              </a:rPr>
              <a:t>α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-Endosulfan sulfate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449802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8944" y="694671"/>
            <a:ext cx="5455253" cy="484887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37028" y="694671"/>
            <a:ext cx="4674358" cy="484887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248167" y="1801504"/>
            <a:ext cx="5245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(k)</a:t>
            </a:r>
            <a:endParaRPr lang="en-US" sz="2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7849737" y="1514900"/>
            <a:ext cx="4523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(l)</a:t>
            </a:r>
            <a:endParaRPr lang="en-US" sz="2400" b="1" dirty="0"/>
          </a:p>
        </p:txBody>
      </p:sp>
      <p:sp>
        <p:nvSpPr>
          <p:cNvPr id="2" name="Rectangle 1"/>
          <p:cNvSpPr/>
          <p:nvPr/>
        </p:nvSpPr>
        <p:spPr>
          <a:xfrm>
            <a:off x="1761861" y="5658921"/>
            <a:ext cx="51155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I 1 </a:t>
            </a:r>
            <a:r>
              <a:rPr lang="en-US" b="1" dirty="0" err="1" smtClean="0">
                <a:latin typeface="Times New Roman" panose="02020603050405020304" pitchFamily="18" charset="0"/>
                <a:ea typeface="Calibri" panose="020F0502020204030204" pitchFamily="34" charset="0"/>
              </a:rPr>
              <a:t>k&amp;l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Calibration curves of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k)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Dieldrin,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l)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DD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705226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2629" y="520559"/>
            <a:ext cx="5706159" cy="545161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47885" y="520559"/>
            <a:ext cx="5188939" cy="545161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228299" y="1569493"/>
            <a:ext cx="6158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dirty="0" smtClean="0"/>
              <a:t>(m)</a:t>
            </a:r>
            <a:endParaRPr 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7235589" y="1569493"/>
            <a:ext cx="5325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dirty="0" smtClean="0"/>
              <a:t>(n)</a:t>
            </a:r>
            <a:endParaRPr lang="en-US" sz="2400" dirty="0"/>
          </a:p>
        </p:txBody>
      </p:sp>
      <p:sp>
        <p:nvSpPr>
          <p:cNvPr id="2" name="Rectangle 1"/>
          <p:cNvSpPr/>
          <p:nvPr/>
        </p:nvSpPr>
        <p:spPr>
          <a:xfrm>
            <a:off x="976312" y="5972175"/>
            <a:ext cx="766762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I 1m&amp;n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Calibration curves of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 (m)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Endrin,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n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) </a:t>
            </a:r>
            <a:r>
              <a:rPr lang="en-US" dirty="0">
                <a:latin typeface="Times New Roman" panose="02020603050405020304" pitchFamily="18" charset="0"/>
                <a:ea typeface="TimesNewRomanPSMT"/>
              </a:rPr>
              <a:t>β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-Endosulfan sulfate</a:t>
            </a:r>
            <a:r>
              <a:rPr lang="en-US" dirty="0">
                <a:latin typeface="Times New Roman" panose="02020603050405020304" pitchFamily="18" charset="0"/>
                <a:ea typeface="TimesNewRomanPSMT"/>
              </a:rPr>
              <a:t> (β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-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86288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2629" y="364055"/>
            <a:ext cx="5474147" cy="543667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44564" y="364055"/>
            <a:ext cx="5119306" cy="543667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965278" y="1965278"/>
            <a:ext cx="5421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(o)</a:t>
            </a:r>
            <a:endParaRPr lang="en-US" sz="2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7109321" y="1965277"/>
            <a:ext cx="5421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(p)</a:t>
            </a:r>
            <a:endParaRPr lang="en-US" sz="2400" b="1" dirty="0"/>
          </a:p>
        </p:txBody>
      </p:sp>
      <p:sp>
        <p:nvSpPr>
          <p:cNvPr id="2" name="Rectangle 1"/>
          <p:cNvSpPr/>
          <p:nvPr/>
        </p:nvSpPr>
        <p:spPr>
          <a:xfrm>
            <a:off x="1284388" y="5800725"/>
            <a:ext cx="665946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I  1o&amp;p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. Calibration curves of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o)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DDD,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p)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Endrin aldehyd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011907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5208" y="356786"/>
            <a:ext cx="5719808" cy="541536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05016" y="356786"/>
            <a:ext cx="5625009" cy="541536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419367" y="1869743"/>
            <a:ext cx="5421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(q)</a:t>
            </a:r>
            <a:endParaRPr lang="en-US" sz="2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7213568" y="1869743"/>
            <a:ext cx="4860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(r)</a:t>
            </a:r>
            <a:endParaRPr lang="en-US" sz="2400" b="1" dirty="0"/>
          </a:p>
        </p:txBody>
      </p:sp>
      <p:sp>
        <p:nvSpPr>
          <p:cNvPr id="2" name="Rectangle 1"/>
          <p:cNvSpPr/>
          <p:nvPr/>
        </p:nvSpPr>
        <p:spPr>
          <a:xfrm>
            <a:off x="1052016" y="5943971"/>
            <a:ext cx="9120684" cy="3886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57200" indent="457200">
              <a:lnSpc>
                <a:spcPct val="107000"/>
              </a:lnSpc>
              <a:spcAft>
                <a:spcPts val="800"/>
              </a:spcAft>
            </a:pPr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 1q&amp;r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alibration curves of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)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ndosulfan sulfate,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)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DT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85119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</TotalTime>
  <Words>231</Words>
  <Application>Microsoft Office PowerPoint</Application>
  <PresentationFormat>Widescreen</PresentationFormat>
  <Paragraphs>31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7" baseType="lpstr">
      <vt:lpstr>Arial</vt:lpstr>
      <vt:lpstr>Calibri</vt:lpstr>
      <vt:lpstr>Calibri Light</vt:lpstr>
      <vt:lpstr>Times New Roman</vt:lpstr>
      <vt:lpstr>TimesNewRomanPSM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Microsoft account</cp:lastModifiedBy>
  <cp:revision>12</cp:revision>
  <dcterms:created xsi:type="dcterms:W3CDTF">2025-04-29T19:35:27Z</dcterms:created>
  <dcterms:modified xsi:type="dcterms:W3CDTF">2025-12-15T19:22:34Z</dcterms:modified>
</cp:coreProperties>
</file>